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D0C407-6A30-32A1-4F0C-F5359C1CBB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289211-DCAA-F839-8A8F-7C24A829F9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632ADD-0411-0BB6-6660-3D6426BDF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1C56A-C15E-1525-E669-EEC24851C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F9E5F-917B-FC8F-D3C0-74E5C5D9F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87936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8A721-842C-0380-82FA-59504F5187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AF4F4D-64B5-2614-567E-018DB08492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D2F932-79C4-D414-7963-56DEF5409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07E514-C548-0C12-982E-D393F90FB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C1205-0886-8B6D-B27E-E9010100D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9796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2096D7-E46E-A8ED-6ADD-9F4AE85424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3A178B-4F06-9947-117B-7598AC81B8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C06B21-B8DE-B1B6-9358-B4FC5336A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B60C6-B01B-86BD-D15A-5E8CC6271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314750-95FC-A690-337F-90CF5C16F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04215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EF5A0-3574-244F-AF52-7E3580DBA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090AA4-5CD4-FA52-DEE2-1C4C705DB5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EA68AE-B93A-27B0-9974-38FC4D292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BB19CF-BCE1-DDAD-0BA7-65EE8FFC4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875F2-3B94-3BB8-15D5-739DF7B74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15975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9B411-F0F5-3D7C-CF22-90E3992CE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05300D-0741-17FC-8A82-9AC63D9C0E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021E3-F7E5-8E23-C9DA-A9E6A10ED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1AABE2-21DC-DE29-2179-E11AE1CA4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FF72A1-18B3-73EA-3FCB-C3489C5BD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35169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BEC7F-EF79-95B6-E7D7-3ECB55F7EC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9663A-B372-B011-5654-A09846FCEA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D5B9A4-B37D-63C8-19D1-DBBF174A07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992D82-1F25-1B56-2212-A72AAC8A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CD3D97-36B4-420F-3F98-9CB7C50AA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D042DF-FA3F-438C-8AED-49CDF1B0C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74474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CD394-2BE6-3EF9-E68E-D71A1A6E2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54C627-4582-5AAF-AAFF-F8242C0728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157810-35EF-0A60-FD71-44ADDA9CD3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9142D54-677C-0E71-F339-3554F4C101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593047-CBBD-925A-84B2-A85807CE6E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ECB719-395C-2753-AB58-DE3BB2699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D93B62-0D8F-4A63-BDEF-B86CBADC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566813-1873-332B-0C8B-B1E4F6706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6376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52D76-0DC1-05E0-E3A0-9BA5C6A49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678844-4511-4F7C-4D5F-674027654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FA94CD-A717-68D1-F079-C121F4D8A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17A0E6-34DE-FC97-7629-A81C41770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941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01C544-EFFB-2B5F-DE4C-63D284FC3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DCE1D1-BC2F-61FF-3683-5A0218D67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133166D-F427-F171-7B7E-5570C2863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93275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AEAE4-1BBC-F13A-A95B-512B099F0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615D85-BFB1-E2B0-3DAF-1BDBB19F6B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81EA2D-6C00-50AE-1BC1-256AB58C4C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F83750-A0AE-C333-35A9-07B7CAE32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2E6D4A-4874-CC0B-DC5D-43E614401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692E8D-74AA-08D8-2B5D-87B1D1DEF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81339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C4932-C2D6-BE48-7AC1-89F0CCB426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3B193A-3220-7EF6-DB70-134CDC68E1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63399D-619F-84F2-F881-49A81B528F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8C9F84-D933-A3A6-D351-3F151C985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A68361-CC62-F407-5415-8A1781A23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326830-30C4-2FA4-24EF-7CE810748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43303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0EC5BC-561D-484F-73AB-F986E129C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6C27A4-2704-AFF2-FCCD-B091B640A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730312-FCE3-B8A1-CD47-40F460F805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7F4F6-B19F-4F6F-BF8A-423564FBF3A5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102BA8-C9EB-6FE2-033C-469CF230FB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CB3D7D-496A-8645-43DD-5A6868788E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29C04-A9B6-4F27-AA67-72CBA5DDE81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72618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328601C2-EADF-91C5-63AC-60B67C0A21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4892" y="54857"/>
            <a:ext cx="5442215" cy="674828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FAFA4A2-D715-5BF6-8AE0-18DC214D71D6}"/>
              </a:ext>
            </a:extLst>
          </p:cNvPr>
          <p:cNvSpPr txBox="1"/>
          <p:nvPr/>
        </p:nvSpPr>
        <p:spPr>
          <a:xfrm>
            <a:off x="9026554" y="2902591"/>
            <a:ext cx="267608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6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 2% agarose gel loaded with the PCR amplification products of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chner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nscripts that were amplified from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uraphis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xi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DNA generated with oligo dT(</a:t>
            </a:r>
            <a:r>
              <a:rPr lang="en-ZA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primers.</a:t>
            </a:r>
          </a:p>
          <a:p>
            <a:endParaRPr lang="en-Z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1365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Dr [nfvburger@sun.ac.za]</dc:creator>
  <cp:lastModifiedBy>Oberholster, A, Prof [ambo@sun.ac.za]</cp:lastModifiedBy>
  <cp:revision>3</cp:revision>
  <dcterms:created xsi:type="dcterms:W3CDTF">2023-10-17T13:04:15Z</dcterms:created>
  <dcterms:modified xsi:type="dcterms:W3CDTF">2024-01-17T12:38:09Z</dcterms:modified>
</cp:coreProperties>
</file>